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  <p:sldId id="280" r:id="rId3"/>
    <p:sldId id="28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7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75" y="50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18297-AB84-4188-BFAB-B90C565DF8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285BCA-8F55-4F0E-8BBE-FDAD967607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212E6A-400A-492F-8AC0-45220DCEA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38E0DC-D1C4-4A0E-A682-A9C85BE2D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2EB25-8B32-4498-AFD6-98905900B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539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39B7FF-EB11-43C4-B0D8-347520F5F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E12E6A-A406-4789-99D1-E19C935BD8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6AE53C-03EB-4E35-AB31-A1CDA0F47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052E04-6FF9-4059-870A-3A1CB744A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ED80CC-FDEA-428D-B572-0998C2348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497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6958FC-46FD-4253-857A-A1131FD1E7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8BC8BD-B3C6-44A6-8006-D433BCA3B9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8D9C48-83B1-4F1E-AA6E-C5DCF5C6E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C42BF6-EB44-4FE7-AE15-CF6755F82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77348B-8889-485B-AB5F-6A6AEE959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526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C90DC0-4EBE-4009-8713-150DAF0896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A0A2BF-C163-4060-BB62-96C7D4D651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1970B0-7B00-4829-AC62-FDDC90EB3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C45EE-018D-4AC9-9B49-1E3ED852CD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53D79-C581-407C-A3DA-59D10A7C3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81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14B1BD-AA2D-4109-9516-57BB56698B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513044-0869-482D-89FE-6BE4FACA20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1315DC-32CF-4B2A-BFE4-2EF2603E3E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9858D-2BCA-4752-84D8-8799BF049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60C509-8BCD-4460-AD9A-308B72CB7D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619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FEC33-9B9C-408E-9846-2B16FD4CAD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528F32-43AC-40F7-83A5-9BE422E56F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070AFE-6E1E-4D40-A469-0615D2B126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0C561A-0CE1-43BF-9BE4-80BB52731F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9AF6E4-6BA6-48DB-9759-85CD91C8F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D9B8F7-FB22-414D-A74B-194B43ACD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297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EEEB23-4B5A-461E-B614-A256E1405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9D72A5-E530-48A9-BD22-21DA271E27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4212CB-770C-494D-B4D2-DCED06B350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4BF618-3575-459D-9F42-F5779835C9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B59C75-10A6-405E-953A-7D45D1A09B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B40335-752C-492B-8F36-49CED3181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0D3F99-4B7F-49AB-B48A-9D5690490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EDF842-57B8-456C-A346-EF97AAAF2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017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2A388-39C8-49DE-975F-3B9CD175DD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498401-4472-483F-B7BD-3E5D5BFC5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C7BCC4-0951-4E9E-8487-606C14000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B91FA4-F56B-478D-AAF5-A06BD7A62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81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038F468-88FE-4B8E-9954-C8F1FB7A5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D600C4-5A06-40C3-9A7D-7E3BB1D65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A4865F-D9FA-48E6-BD7F-68F83D9E9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019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0319A-440B-4535-B97E-D4088A515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70A1E3-B23A-4796-86C1-FFBCC695F9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C8FA9B-61BA-4C31-B846-F53E312721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53BADE-430F-49A9-9E83-A95CECA04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61BDA8-2019-4255-A817-4ABC58E49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52C9E0-101B-418D-9016-8E9401655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894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75FF9-33C1-4118-8873-4F0E39B37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449977-DC63-47C9-8974-24C49E32AB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0A17EA-DF53-4DAE-A034-917DA24B59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979AF-E569-4843-BB8B-3CC9D68FE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9A5636-A5BD-4741-BAA7-6F0B38C969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90CBFE-5B8F-4E12-A505-CBB6FE23E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714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D69B4C-0981-429F-935C-A10575167B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864947-63F4-4935-A1FF-2AD31C6CCD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4D4690-267A-458B-8225-FCD249A725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5707EB-BACE-4478-B3E4-EEF84CFE4767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66D601-F225-4FEF-BE23-F40D7160D6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1EF45-E3F6-4333-BE70-B7A4743609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3F4DF-07F4-4D7B-B4EE-395052EAFC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308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1A5C2-58A5-4DF4-B4E4-745FF822C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marL="0" marR="0">
              <a:lnSpc>
                <a:spcPct val="115000"/>
              </a:lnSpc>
              <a:spcBef>
                <a:spcPts val="2000"/>
              </a:spcBef>
              <a:spcAft>
                <a:spcPts val="600"/>
              </a:spcAft>
            </a:pPr>
            <a:r>
              <a:rPr lang="en-US" sz="2800" b="1" kern="0" dirty="0">
                <a:effectLst/>
                <a:latin typeface="Arial" panose="020B0604020202020204" pitchFamily="34" charset="0"/>
              </a:rPr>
              <a:t>Language distance modulates cognitive control in bilinguals</a:t>
            </a:r>
            <a:endParaRPr lang="en-US" sz="60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8091C9-08EB-44CC-AF3A-368469E6D5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GB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arges Radman, Lea </a:t>
            </a:r>
            <a:r>
              <a:rPr lang="en-GB" sz="11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Jost</a:t>
            </a:r>
            <a:r>
              <a:rPr lang="en-GB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, Setareh </a:t>
            </a:r>
            <a:r>
              <a:rPr lang="en-GB" sz="11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orood</a:t>
            </a:r>
            <a:r>
              <a:rPr lang="en-GB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, Christian Mancini , Jean-Marie </a:t>
            </a:r>
            <a:r>
              <a:rPr lang="en-GB" sz="11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nnoni</a:t>
            </a:r>
            <a:r>
              <a:rPr lang="en-GB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endParaRPr lang="en-US" sz="1100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Linear mixed effect Analyses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50128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054FEA-9886-C84B-A0B9-7A86AC1EE3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b="1" dirty="0"/>
              <a:t>Linear mixed effect analyses on language switching task</a:t>
            </a:r>
            <a:r>
              <a:rPr lang="en-CH" sz="2800" b="1" dirty="0"/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2E7D4FF-6C87-44C9-B58E-C844BF3483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97447" y="1901154"/>
            <a:ext cx="5169856" cy="243861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5311F53-1A12-49A8-96BC-F211AAB582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1335" y="1738263"/>
            <a:ext cx="5706351" cy="4200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4785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E68A9897-21E7-425B-8235-D4CE16B07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rmAutofit/>
          </a:bodyPr>
          <a:lstStyle/>
          <a:p>
            <a:r>
              <a:rPr lang="en-US" sz="2800" b="1" dirty="0"/>
              <a:t>Linear mixed effect analyses </a:t>
            </a:r>
            <a:r>
              <a:rPr lang="en-US" sz="2800" b="1"/>
              <a:t>on Nonlinguistic </a:t>
            </a:r>
            <a:r>
              <a:rPr lang="en-US" sz="2800" b="1" dirty="0"/>
              <a:t>switching task</a:t>
            </a:r>
            <a:r>
              <a:rPr lang="en-CH" sz="2800" b="1" dirty="0"/>
              <a:t>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9F8D6BF-B608-2B43-B511-8396F1A5FF1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525"/>
          <a:stretch/>
        </p:blipFill>
        <p:spPr>
          <a:xfrm>
            <a:off x="514233" y="1520261"/>
            <a:ext cx="6591213" cy="433895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2C31760-F073-5B4F-93DA-0B38A901BD2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707" r="9900" b="85551"/>
          <a:stretch/>
        </p:blipFill>
        <p:spPr>
          <a:xfrm>
            <a:off x="6941083" y="2075832"/>
            <a:ext cx="4577080" cy="653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4299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2</Words>
  <Application>Microsoft Office PowerPoint</Application>
  <PresentationFormat>Widescreen</PresentationFormat>
  <Paragraphs>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Language distance modulates cognitive control in bilinguals</vt:lpstr>
      <vt:lpstr>Linear mixed effect analyses on language switching task </vt:lpstr>
      <vt:lpstr>Linear mixed effect analyses on Nonlinguistic switching task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rges Radman</dc:creator>
  <cp:lastModifiedBy>Narges Radman</cp:lastModifiedBy>
  <cp:revision>6</cp:revision>
  <dcterms:created xsi:type="dcterms:W3CDTF">2021-07-15T13:41:10Z</dcterms:created>
  <dcterms:modified xsi:type="dcterms:W3CDTF">2021-10-07T18:57:00Z</dcterms:modified>
</cp:coreProperties>
</file>